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6" d="100"/>
          <a:sy n="46" d="100"/>
        </p:scale>
        <p:origin x="2837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876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2891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035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372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053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992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3941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46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977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859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9968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7160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6CA526D-B4D3-41CF-91E3-64F91FA61F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1185" y="0"/>
            <a:ext cx="4875630" cy="8158650"/>
          </a:xfrm>
          <a:prstGeom prst="rect">
            <a:avLst/>
          </a:prstGeom>
          <a:noFill/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0FEAE030-ED22-4D9E-B09A-669BC2902546}"/>
              </a:ext>
            </a:extLst>
          </p:cNvPr>
          <p:cNvSpPr/>
          <p:nvPr/>
        </p:nvSpPr>
        <p:spPr>
          <a:xfrm>
            <a:off x="1" y="8158650"/>
            <a:ext cx="685799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1200" b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) Plant phenotype of 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lh1 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tants growing in the glasshouse at 10 weeks post germination. Each gene-edited line (left) was compared to 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v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olden Promise (right). Below, mature grain phenotype harvested from the same lines. (B) Phenotypic assessment of grain characteristics: thousand grain weight (TGW), overall grain area, grain width and grain length for 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lh1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ines. Asterisks indicate statistically signiﬁcant differences compared to the control (WT) at P &lt; 0.05 (*) using Tukey’s post-hoc test.</a:t>
            </a:r>
            <a:endParaRPr lang="en-GB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24302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9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egoe U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illermo Garcia</dc:creator>
  <cp:lastModifiedBy>Guillermo Garcia</cp:lastModifiedBy>
  <cp:revision>9</cp:revision>
  <dcterms:created xsi:type="dcterms:W3CDTF">2020-05-14T00:51:09Z</dcterms:created>
  <dcterms:modified xsi:type="dcterms:W3CDTF">2020-05-14T01:33:57Z</dcterms:modified>
</cp:coreProperties>
</file>